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2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1/06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6002402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lorez</a:t>
            </a:r>
            <a:r>
              <a:rPr lang="en-GB" dirty="0"/>
              <a:t> and Pearson (2022) Diabetologia DOI 10.1007/s00125-022-05732-3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</a:rPr>
              <a:t>R</a:t>
            </a:r>
            <a:r>
              <a:rPr lang="en-GB" sz="1800" b="1" i="0" u="none" strike="noStrike" baseline="0" dirty="0">
                <a:latin typeface="Arial" panose="020B0604020202020204" pitchFamily="34" charset="0"/>
              </a:rPr>
              <a:t>oadmap to achieve pharmacological precision medicine in diabete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1EB9685-AB45-E475-1BE0-F39737ACCD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9165" y="780456"/>
            <a:ext cx="7985670" cy="52219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i="0" u="none" strike="noStrike" baseline="0" dirty="0">
                <a:latin typeface="Arial" panose="020B0604020202020204" pitchFamily="34" charset="0"/>
              </a:rPr>
              <a:t>Anatomical analogy of a predictive tool for precision prediction that incorporates relevant axes of biology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BB03D15-3C70-927D-B1DB-A7D2CE186D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536" y="1129656"/>
            <a:ext cx="8111058" cy="449937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F89A211-7533-B01F-0CEA-AF4486EA4231}"/>
              </a:ext>
            </a:extLst>
          </p:cNvPr>
          <p:cNvSpPr txBox="1"/>
          <p:nvPr/>
        </p:nvSpPr>
        <p:spPr>
          <a:xfrm>
            <a:off x="102955" y="6033376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lorez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and Pearson (2022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2-05732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2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On-screen Show (4:3)</PresentationFormat>
  <Paragraphs>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0</cp:revision>
  <dcterms:created xsi:type="dcterms:W3CDTF">2016-06-15T12:53:43Z</dcterms:created>
  <dcterms:modified xsi:type="dcterms:W3CDTF">2022-06-21T10:29:47Z</dcterms:modified>
</cp:coreProperties>
</file>